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263" r:id="rId3"/>
    <p:sldId id="264" r:id="rId4"/>
    <p:sldId id="262" r:id="rId5"/>
    <p:sldId id="268" r:id="rId6"/>
    <p:sldId id="265" r:id="rId7"/>
    <p:sldId id="26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27"/>
    <p:restoredTop sz="87644"/>
  </p:normalViewPr>
  <p:slideViewPr>
    <p:cSldViewPr snapToGrid="0" snapToObjects="1">
      <p:cViewPr varScale="1">
        <p:scale>
          <a:sx n="91" d="100"/>
          <a:sy n="91" d="100"/>
        </p:scale>
        <p:origin x="9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41EEF3-0D8B-4048-A5F9-2133ACC12F36}" type="datetimeFigureOut">
              <a:rPr lang="en-US" smtClean="0"/>
              <a:t>9/1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C4795E-C266-A943-A84C-55611728C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58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none" dirty="0"/>
              <a:t>Supplementary figure 1:</a:t>
            </a:r>
            <a:r>
              <a:rPr lang="en-US" u="none" dirty="0"/>
              <a:t> </a:t>
            </a:r>
            <a:r>
              <a:rPr lang="en-US" sz="1200" u="non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arison of cumulative 5-locus haplotype frequency of the SSCDR HLA database and </a:t>
            </a:r>
            <a:r>
              <a:rPr lang="en-US" sz="1200" u="non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fraih</a:t>
            </a:r>
            <a:r>
              <a:rPr lang="en-US" sz="1200" u="non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t al..</a:t>
            </a:r>
            <a:r>
              <a:rPr lang="en-US" u="none" dirty="0">
                <a:effectLst/>
              </a:rPr>
              <a:t> </a:t>
            </a:r>
            <a:endParaRPr lang="en-US" u="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75AD-16BB-F74B-97F2-D13B035168E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0303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Comparison of 5-locus based haplotype frequencies based on the SSCDR database and KFSH&amp;RC dataset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frai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t al. 2021)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75AD-16BB-F74B-97F2-D13B035168E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125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:</a:t>
            </a:r>
            <a:r>
              <a:rPr lang="en-US" dirty="0"/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 lines authentication. (A) Short Tandem Repeat (STR) profiling guaranteed the genetic identity between the established iPSC lines and the donor EPCs. (B) PCR analysis detected the absence of Epi5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soma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lasmids in the indicated lines at passage 12. (C) RT-qPCR showing negative mycoplasma test in HLA-iPSC lines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75AD-16BB-F74B-97F2-D13B035168E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2677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Tandem duplication on chromosome 16 in cell line iPSC#1 visualized using IGV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75AD-16BB-F74B-97F2-D13B035168E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60681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Single nucleotide polymorphisms for donor blood sample and cell lines iPSC#1 and iPSC#2. The fraction of genotype calls matching with donor was calculated fo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allel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NP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75AD-16BB-F74B-97F2-D13B035168E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99775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3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Subtractive SNP calls for cell lines HLA-iPSC1 and HLA-iPSC2 vs. donor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BE75AD-16BB-F74B-97F2-D13B035168E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352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3DDC44-C1C3-1B4D-8834-BAA1815661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A5BFCD-3681-C847-85AE-9F694E742C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445E46-4B67-9146-9FD9-B5B58FF87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EE9E9C-9E0C-4645-9915-2530B5A12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B031E6-80C9-9346-8C92-943CA845F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830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19DDA-174F-3F4E-BC32-98C361F50A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B6AA4E-B814-CB46-BB72-BF3D3DFFCA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25BE89-1FF7-C24D-A85E-756618BD9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C345D-F402-A743-8164-CB12BE40F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0EA0B-8C51-F944-A49C-ADD8E3804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742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8E06E6-FF22-A843-B9F3-1479E3DC47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AFEEE0-888C-2444-8110-A237797A4B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6F90E6-EBE4-2542-98C6-FD4C267B6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E2415-4751-A949-A7F7-DA68A9FBB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FBFDA3-F472-6F45-9411-0E017B10C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703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012BF-519D-AF41-BED9-BCC9B9CF06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3BA5E0-FE0A-9D45-91E4-DB94795355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B9C0FB-C54B-914E-AA97-E6DEA4E8F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73770C-60CF-4049-8B46-6B44BE7DF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9E97C2-C8EA-CD4B-A46B-D1443FC94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519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11839-34C6-3F45-A6AB-688E27835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C8AEFB-4BC4-6A42-A233-091E1C5146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A153E8-7570-B743-A0E0-102AF6467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7428E3-78B4-5F44-871C-595E16B74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76AFD5-A184-074E-83EA-12538657D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333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48B25-6C98-5045-A12C-3AF771DAB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DB68C7-C754-604B-B801-111F9A38CA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805404-200B-0B4E-A501-0A660A7A9C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6F7BA1-A1D6-E747-BBB6-040F06307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22E29D-B236-AD47-AF01-F258B6EC3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9BCBC0-B1FE-D840-B170-30DEA486F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025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21AD5-7FEA-B84F-98ED-0692BF3B0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3DDDD0-461D-AF49-BFFD-CAD566E8A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1ADD7B-A8BA-2F46-9ED4-6FF62579DA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A0B9EC-AE24-5F42-9B58-B14F0F70F0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DF98D6-33AC-334B-9F01-CCB86124D8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4DF656-5E62-CC4A-8D99-C8B69D1D8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466E20-CB01-3E49-80B7-6C3374985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96FCD5-9937-2C49-A202-F26AD4674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389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D10546-7653-4848-9383-D7C29BF72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BD74D8-AEC4-3C41-9EC9-69624247A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92DDC9-7F86-B142-B5BE-1D24D263F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750FA9E-C2D3-774E-A9E7-11FEE8EC0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618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0EEFAC-50B9-0A42-8199-2B61536B4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0EB53A-370B-8740-B494-C68AC881F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D7A6B2-DEB3-FD44-94E7-E9C3F515C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270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0F5CBC-0777-4143-8FF8-0A27A83DF0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FEC0F8-5DD1-5E45-969F-9CEA916392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155C19-8091-A54C-9C01-443273EB0A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EC726-A12D-0C47-A571-DCCC66DF7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9BDC5F-43ED-EE45-AA06-B91166B2D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53D6F5-D434-0E4F-888E-752555A11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33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A767C-A508-DC43-989B-7AE960FEC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5D3EFC-FCF7-E44E-A7F9-7479A0EA5D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B54FEF-30BB-D447-AF41-6783A446B0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3DAF52-4081-6F4E-9A6F-3861F4F8B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3A4DF-5907-C448-B42D-873BA0176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D61A5C-18CD-AB43-AAF4-349736B54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040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ED2D55-FEE3-2743-914C-E25552E07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21F746-1893-F645-BB59-EC763F346B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56C6A-D08B-4144-8DD4-C97515AF29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F90BA-DBFC-E944-B745-299BA6654EB9}" type="datetimeFigureOut">
              <a:rPr lang="en-US" smtClean="0"/>
              <a:t>9/1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2CEF5-257D-A846-A834-935ED2E8D7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67F2A7-03C5-814D-97A7-67D054FD3A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D55D30-F093-8540-B9E8-9991584C3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668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2D865-8B0D-D947-AF53-5F994D9E63C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Dat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43A0BB-DB16-414D-B10A-D7794E64440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271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5D1CEA1-2A79-1149-87AC-E92F4885929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2" t="51239"/>
          <a:stretch/>
        </p:blipFill>
        <p:spPr>
          <a:xfrm>
            <a:off x="3441700" y="1460500"/>
            <a:ext cx="4787748" cy="3000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5979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ontent Placeholder 10">
            <a:extLst>
              <a:ext uri="{FF2B5EF4-FFF2-40B4-BE49-F238E27FC236}">
                <a16:creationId xmlns:a16="http://schemas.microsoft.com/office/drawing/2014/main" id="{4C87FBE6-BBA6-5D44-B285-700F3359C3BB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279400" y="152400"/>
          <a:ext cx="11633200" cy="5680069"/>
        </p:xfrm>
        <a:graphic>
          <a:graphicData uri="http://schemas.openxmlformats.org/drawingml/2006/table">
            <a:tbl>
              <a:tblPr firstRow="1" firstCol="1" bandRow="1">
                <a:tableStyleId>{0505E3EF-67EA-436B-97B2-0124C06EBD24}</a:tableStyleId>
              </a:tblPr>
              <a:tblGrid>
                <a:gridCol w="337475">
                  <a:extLst>
                    <a:ext uri="{9D8B030D-6E8A-4147-A177-3AD203B41FA5}">
                      <a16:colId xmlns:a16="http://schemas.microsoft.com/office/drawing/2014/main" val="2012302875"/>
                    </a:ext>
                  </a:extLst>
                </a:gridCol>
                <a:gridCol w="3558129">
                  <a:extLst>
                    <a:ext uri="{9D8B030D-6E8A-4147-A177-3AD203B41FA5}">
                      <a16:colId xmlns:a16="http://schemas.microsoft.com/office/drawing/2014/main" val="3464415375"/>
                    </a:ext>
                  </a:extLst>
                </a:gridCol>
                <a:gridCol w="1070464">
                  <a:extLst>
                    <a:ext uri="{9D8B030D-6E8A-4147-A177-3AD203B41FA5}">
                      <a16:colId xmlns:a16="http://schemas.microsoft.com/office/drawing/2014/main" val="919513226"/>
                    </a:ext>
                  </a:extLst>
                </a:gridCol>
                <a:gridCol w="1072791">
                  <a:extLst>
                    <a:ext uri="{9D8B030D-6E8A-4147-A177-3AD203B41FA5}">
                      <a16:colId xmlns:a16="http://schemas.microsoft.com/office/drawing/2014/main" val="3236696929"/>
                    </a:ext>
                  </a:extLst>
                </a:gridCol>
                <a:gridCol w="3548822">
                  <a:extLst>
                    <a:ext uri="{9D8B030D-6E8A-4147-A177-3AD203B41FA5}">
                      <a16:colId xmlns:a16="http://schemas.microsoft.com/office/drawing/2014/main" val="3396255097"/>
                    </a:ext>
                  </a:extLst>
                </a:gridCol>
                <a:gridCol w="1065811">
                  <a:extLst>
                    <a:ext uri="{9D8B030D-6E8A-4147-A177-3AD203B41FA5}">
                      <a16:colId xmlns:a16="http://schemas.microsoft.com/office/drawing/2014/main" val="4027870739"/>
                    </a:ext>
                  </a:extLst>
                </a:gridCol>
                <a:gridCol w="979708">
                  <a:extLst>
                    <a:ext uri="{9D8B030D-6E8A-4147-A177-3AD203B41FA5}">
                      <a16:colId xmlns:a16="http://schemas.microsoft.com/office/drawing/2014/main" val="1208982322"/>
                    </a:ext>
                  </a:extLst>
                </a:gridCol>
              </a:tblGrid>
              <a:tr h="348809"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SCDR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lfrahi 2021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0426110"/>
                  </a:ext>
                </a:extLst>
              </a:tr>
              <a:tr h="4846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Haplotyp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Frequenc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Cumulative Frequenc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Haplotyp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Frequenc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Cumulative Frequenc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0473519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02:01g~C*06:02g~B*50:01g~DQB1*02:01g~DRB1*07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867507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867507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5g~C*06:02g~B*50:01g~DQB1*02:01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729989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72998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3620188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02:05g~C*06:02g~B*50:01g~DQB1*02:01g~DRB1*07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790179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365768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1g~C*06:02g~B*50:01g~DQB1*02:01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662049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339203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1254218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26:01g~C*07:02g~B*0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383072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5040759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26:01g~C*07:02g~B*0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379316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477135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759789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4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23:01g~C*06:02g~B*50:01g~DQB1*02:01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312331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6353090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23:01g~C*06:02g~B*50:01g~DQB1*02:01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230872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600222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7408294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1:01g~C*15:02g~B*51:01g~DQB1*06:03g~DRB1*1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262872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7615963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1g~C*07:02g~B*07:02g~DQB1*06:02g~DRB1*15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112914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711514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3082981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1g~C*07:02g~B*07:02g~DQB1*06:02g~DRB1*15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223273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8839236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01:01g~C*17:01g~B*41:01~DQB1*03:03g~DRB1*07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997177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81123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6445153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7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1g~C*15:02g~B*51:01g~DQB1*03:02g~DRB1*04:02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177477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0016713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31:01g~C*15:02g~B*51:01g~DQB1*06:03g~DRB1*13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940470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90527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865368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8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1:01g~C*17:01g~B*41:01g~DQB1*03:03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859872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0876586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1g~C*15:02g~B*51:01g~DQB1*03:02g~DRB1*04:0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933789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99865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0054540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68:01g~C*07:02g~B*0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85332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1729908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24:02g~C*07:02g~B*08:01g~DQB1*02:01g~DRB1*03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909205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089578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2760556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24:02g~C*07:02g~B*0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846796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2576704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68:01g~C*07:02g~B*0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0818208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171399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5692318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1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1:01g~C*06:02g~B*50:01g~DQB1*02:01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643842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3220547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1:03~C*15:05g~B*73:01~DQB1*05:01g~DRB1*10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063058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23445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5288684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2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3:03g~C*03:02g~B*5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622880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3843427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3:01g~C*08:02g~B*14:02g~DQB1*05:01g~DRB1*01:02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0608192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295277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8938116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3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33:01g~C*08:02g~B*14:02g~DQB1*05:01g~DRB1*01:02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600961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4444388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3:03g~C*03:02g~B*58:01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00575874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352864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8595747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4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30:02g~C*04:01g~B*53:01g~DQB1*06:09g~DRB1*13:02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81680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502606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1:01g~C*06:02g~B*50:01g~DQB1*02:01g~DRB1*07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3925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406789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2527465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5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02:01g~C*14:02g~B*51:01g~DQB1*06:02g~DRB1*15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37597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5563666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02:01g~C*07:02g~B*07:02g~DQB1*02:01g~DRB1*0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367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460461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4290528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6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02:01g~C*07:02g~B*07:02g~DQB1*02:01g~DRB1*03:01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04114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606778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11:01g~C*12:02g~B*52:01g~DQB1*06:01g~DRB1*15:02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25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512976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3750897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7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*24:02g~C*07:01g~B*15:17g~DQB1*06:04g~DRB1*13:02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78321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6546102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0:01g~C*17:01g~B*42:01g~DQB1*04:02g~DRB1*03:0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500292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56300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6234574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8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68:01g~C*07:02g~B*07:02g~DQB1*03:02g~DRB1*04:03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71816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7017919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1:01g~C*01:02g~B*15:08~DQB1*06:03g~DRB1*1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90304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612036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0559741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11:01g~C*12:02g~B*52:01g~DQB1*06:01g~DRB1*15:02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59445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7477365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24:02g~C*07:01g~B*15:17~DQB1*06:04g~DRB1*13:02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84747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660511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4033703"/>
                  </a:ext>
                </a:extLst>
              </a:tr>
              <a:tr h="2423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31:01g~C*01:02g~B*15:08~DQB1*06:03g~DRB1*13:01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29413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7906778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*68:01g~C*07:02g~B*07:02g~DQB1*03:02g~DRB1*04:03g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459895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706500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7972" marR="37972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92005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3023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04D7D15-1E07-4A4D-B63F-3D69BE5F663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4684" y="91839"/>
            <a:ext cx="4811831" cy="6801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6841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7FB59AC-C69A-A946-B50E-450C29B90DA6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200" y="1341120"/>
            <a:ext cx="5943600" cy="4175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78652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FC3A8650-54B5-D14F-8E27-395B3199B6A9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838200" y="3124200"/>
          <a:ext cx="10515600" cy="18669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87454">
                  <a:extLst>
                    <a:ext uri="{9D8B030D-6E8A-4147-A177-3AD203B41FA5}">
                      <a16:colId xmlns:a16="http://schemas.microsoft.com/office/drawing/2014/main" val="1200024174"/>
                    </a:ext>
                  </a:extLst>
                </a:gridCol>
                <a:gridCol w="972834">
                  <a:extLst>
                    <a:ext uri="{9D8B030D-6E8A-4147-A177-3AD203B41FA5}">
                      <a16:colId xmlns:a16="http://schemas.microsoft.com/office/drawing/2014/main" val="2443131189"/>
                    </a:ext>
                  </a:extLst>
                </a:gridCol>
                <a:gridCol w="1261872">
                  <a:extLst>
                    <a:ext uri="{9D8B030D-6E8A-4147-A177-3AD203B41FA5}">
                      <a16:colId xmlns:a16="http://schemas.microsoft.com/office/drawing/2014/main" val="3198295364"/>
                    </a:ext>
                  </a:extLst>
                </a:gridCol>
                <a:gridCol w="1261872">
                  <a:extLst>
                    <a:ext uri="{9D8B030D-6E8A-4147-A177-3AD203B41FA5}">
                      <a16:colId xmlns:a16="http://schemas.microsoft.com/office/drawing/2014/main" val="2986178449"/>
                    </a:ext>
                  </a:extLst>
                </a:gridCol>
                <a:gridCol w="1269744">
                  <a:extLst>
                    <a:ext uri="{9D8B030D-6E8A-4147-A177-3AD203B41FA5}">
                      <a16:colId xmlns:a16="http://schemas.microsoft.com/office/drawing/2014/main" val="4001258047"/>
                    </a:ext>
                  </a:extLst>
                </a:gridCol>
                <a:gridCol w="909852">
                  <a:extLst>
                    <a:ext uri="{9D8B030D-6E8A-4147-A177-3AD203B41FA5}">
                      <a16:colId xmlns:a16="http://schemas.microsoft.com/office/drawing/2014/main" val="3225405232"/>
                    </a:ext>
                  </a:extLst>
                </a:gridCol>
                <a:gridCol w="904229">
                  <a:extLst>
                    <a:ext uri="{9D8B030D-6E8A-4147-A177-3AD203B41FA5}">
                      <a16:colId xmlns:a16="http://schemas.microsoft.com/office/drawing/2014/main" val="4173419434"/>
                    </a:ext>
                  </a:extLst>
                </a:gridCol>
                <a:gridCol w="890733">
                  <a:extLst>
                    <a:ext uri="{9D8B030D-6E8A-4147-A177-3AD203B41FA5}">
                      <a16:colId xmlns:a16="http://schemas.microsoft.com/office/drawing/2014/main" val="1091789901"/>
                    </a:ext>
                  </a:extLst>
                </a:gridCol>
                <a:gridCol w="1124664">
                  <a:extLst>
                    <a:ext uri="{9D8B030D-6E8A-4147-A177-3AD203B41FA5}">
                      <a16:colId xmlns:a16="http://schemas.microsoft.com/office/drawing/2014/main" val="4145188061"/>
                    </a:ext>
                  </a:extLst>
                </a:gridCol>
                <a:gridCol w="932346">
                  <a:extLst>
                    <a:ext uri="{9D8B030D-6E8A-4147-A177-3AD203B41FA5}">
                      <a16:colId xmlns:a16="http://schemas.microsoft.com/office/drawing/2014/main" val="1393131542"/>
                    </a:ext>
                  </a:extLst>
                </a:gridCol>
              </a:tblGrid>
              <a:tr h="10668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Sampl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Total # Variant Loci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Total SNP loci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Mean genotype call rat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Heterozygosity ratio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# SNP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# Inser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# Dele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# Substitutio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% Genotype Matching to Donor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701399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Donor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  5,399,434 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         4,277,573 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                99.24 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1.71876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3,931,13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430,87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411,13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101,64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093622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iPSC#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                99.15 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1.71021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3,922,49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430,49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412,29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101,87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94.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0778955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iPSC#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                99.22 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1.72154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3,931,02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434,70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415,43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102,91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94.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10798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051689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9635A-8681-F248-BCB3-E19781AE20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A96378B-CF9A-0A4A-A8EA-D0F08D2403A8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1003301" y="2548731"/>
          <a:ext cx="10185397" cy="1411129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1039934">
                  <a:extLst>
                    <a:ext uri="{9D8B030D-6E8A-4147-A177-3AD203B41FA5}">
                      <a16:colId xmlns:a16="http://schemas.microsoft.com/office/drawing/2014/main" val="2635544236"/>
                    </a:ext>
                  </a:extLst>
                </a:gridCol>
                <a:gridCol w="890465">
                  <a:extLst>
                    <a:ext uri="{9D8B030D-6E8A-4147-A177-3AD203B41FA5}">
                      <a16:colId xmlns:a16="http://schemas.microsoft.com/office/drawing/2014/main" val="2696937795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162045789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1273705904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11083340"/>
                    </a:ext>
                  </a:extLst>
                </a:gridCol>
                <a:gridCol w="876301">
                  <a:extLst>
                    <a:ext uri="{9D8B030D-6E8A-4147-A177-3AD203B41FA5}">
                      <a16:colId xmlns:a16="http://schemas.microsoft.com/office/drawing/2014/main" val="536598053"/>
                    </a:ext>
                  </a:extLst>
                </a:gridCol>
                <a:gridCol w="1104899">
                  <a:extLst>
                    <a:ext uri="{9D8B030D-6E8A-4147-A177-3AD203B41FA5}">
                      <a16:colId xmlns:a16="http://schemas.microsoft.com/office/drawing/2014/main" val="2415854662"/>
                    </a:ext>
                  </a:extLst>
                </a:gridCol>
                <a:gridCol w="698500">
                  <a:extLst>
                    <a:ext uri="{9D8B030D-6E8A-4147-A177-3AD203B41FA5}">
                      <a16:colId xmlns:a16="http://schemas.microsoft.com/office/drawing/2014/main" val="4188372789"/>
                    </a:ext>
                  </a:extLst>
                </a:gridCol>
                <a:gridCol w="998585">
                  <a:extLst>
                    <a:ext uri="{9D8B030D-6E8A-4147-A177-3AD203B41FA5}">
                      <a16:colId xmlns:a16="http://schemas.microsoft.com/office/drawing/2014/main" val="3761109407"/>
                    </a:ext>
                  </a:extLst>
                </a:gridCol>
                <a:gridCol w="759092">
                  <a:extLst>
                    <a:ext uri="{9D8B030D-6E8A-4147-A177-3AD203B41FA5}">
                      <a16:colId xmlns:a16="http://schemas.microsoft.com/office/drawing/2014/main" val="934353074"/>
                    </a:ext>
                  </a:extLst>
                </a:gridCol>
                <a:gridCol w="833121">
                  <a:extLst>
                    <a:ext uri="{9D8B030D-6E8A-4147-A177-3AD203B41FA5}">
                      <a16:colId xmlns:a16="http://schemas.microsoft.com/office/drawing/2014/main" val="1155601315"/>
                    </a:ext>
                  </a:extLst>
                </a:gridCol>
              </a:tblGrid>
              <a:tr h="321469">
                <a:tc>
                  <a:txBody>
                    <a:bodyPr/>
                    <a:lstStyle/>
                    <a:p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utect2 SNP calls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EP Impact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22312644"/>
                  </a:ext>
                </a:extLst>
              </a:tr>
              <a:tr h="6629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Cell Lin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otal Variants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verlapping Genes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# SNP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# Insertion</a:t>
                      </a:r>
                      <a:endParaRPr lang="en-US" sz="13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# Deletion</a:t>
                      </a:r>
                      <a:endParaRPr lang="en-US" sz="13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# Substitution</a:t>
                      </a:r>
                      <a:endParaRPr lang="en-US" sz="13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igh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oderat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ow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odifier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9923499"/>
                  </a:ext>
                </a:extLst>
              </a:tr>
              <a:tr h="20764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LA-iPSC1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610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04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36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9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4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1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606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246077"/>
                  </a:ext>
                </a:extLst>
              </a:tr>
              <a:tr h="20764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LA-iPSC2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888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25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695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1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4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887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7273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21610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12</Words>
  <Application>Microsoft Macintosh PowerPoint</Application>
  <PresentationFormat>Widescreen</PresentationFormat>
  <Paragraphs>233</Paragraphs>
  <Slides>7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Supplementary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</dc:title>
  <dc:creator>Khaled Alsayegh</dc:creator>
  <cp:lastModifiedBy>Khaled Alsayegh</cp:lastModifiedBy>
  <cp:revision>1</cp:revision>
  <dcterms:created xsi:type="dcterms:W3CDTF">2023-09-15T00:19:48Z</dcterms:created>
  <dcterms:modified xsi:type="dcterms:W3CDTF">2023-09-15T00:22:02Z</dcterms:modified>
</cp:coreProperties>
</file>